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73" r:id="rId4"/>
    <p:sldId id="27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6307" autoAdjust="0"/>
  </p:normalViewPr>
  <p:slideViewPr>
    <p:cSldViewPr snapToGrid="0">
      <p:cViewPr varScale="1">
        <p:scale>
          <a:sx n="83" d="100"/>
          <a:sy n="83" d="100"/>
        </p:scale>
        <p:origin x="108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A6E6BC-8EEA-4FAE-8B4F-28A22D849B71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DABAB6-BAE9-4EE5-9FC8-461E70029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996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DABAB6-BAE9-4EE5-9FC8-461E70029DF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776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34BD2E-EBB1-49D5-B0F1-8016D6163D1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9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34BD2E-EBB1-49D5-B0F1-8016D6163D1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643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8A92B-770A-A2E2-10DA-F13416085E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53EFE3-61DA-0E74-5C74-E9C6703104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98D89-6BC4-DBCD-EF1E-E5F7AA65B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D32149-4912-D58C-22F2-534838ADD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15322-5428-F4E3-B15F-461153FBB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19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56514C-3C19-AEC9-8644-9247B797C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1A5A72-3852-2908-693D-FA05857A93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9D1870-32DE-FE8F-9B2A-CBBD759A8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91A358-C537-F9E0-6AD2-8C5967698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5BD737-7B8A-30B3-86B2-7A2A97411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114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CDD315-BA1C-5B08-1703-2F78FD1E5E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2EB8E4-196F-7277-546D-838B4E21D1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7F279C-8E60-1A69-A9EF-2744631EE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93852E-3DAD-BA9E-2597-73184BE67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C364F1-3873-C2A0-DF05-1477D39E3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364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B6612-7949-A265-B3D4-B712667840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4C0F1F-58CD-29D6-ECAC-B7EB20296B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FB8E28-2212-998B-486C-EDDC0D6B9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A4CBC9-D8D5-43E3-C838-FC0ECA625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600C3-976E-D189-9180-41D283BFE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961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C04CA2-12C1-5F4D-D609-6282A3DF5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F4C571-DE42-538A-984C-30AB5D1AB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2FC26-0FD9-32A6-6E9E-1EE8405F4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FD97BF-53CB-0C42-1B21-FBEC5086C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18C18F-6E06-FF5A-6B6C-66DBAA9AA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45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F4AA0-5B41-E5F1-2DC2-DA18CA496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CCAEF6-B4FB-7915-A532-BF94EE7528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9A1633-87A2-549D-A80E-CA6B4ECABA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F70977-EDBD-42E8-3F11-9C34565C6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D2BCDC-917B-7FEA-8590-42040531E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780C4F-85B3-90EF-C5E6-A6F0AFE5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827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F60E6-3CB0-F722-5A9C-B14A5490F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5FD8A8-ED44-3C8E-27BC-57CFD0599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9FCF6E-45AB-8C2A-5DF2-BECE1E5D00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DFA66C-F3C1-4501-9211-C42B0CAED6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7831DEE-0499-E9C1-C9BF-84F22F97D9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776B7C-9D71-7140-0153-E2C4AA00F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528D77-18A6-8BD9-93D7-2E4528910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23E4E8-BB24-0FA1-1DD2-D1A37F07D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202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7DF87-F7F0-CA2B-0CD6-479FA9CAF8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B9697-E6A7-5350-70EA-5375815BE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7ACA80-971C-D4C1-F7BC-2DF3990F9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3EC487-3BF8-E04F-B9EB-B8D0F1C3C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28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14579E-C7E1-FFF2-6315-CFD9A2F8E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EAEF77-2635-392C-2E26-5EE42C730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DB296A-10EB-35B6-009F-2607B14BC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13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0A4758-FD42-5C5B-ED68-FBED8101F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EDC419-A86B-EFEE-B918-DB03489533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35B416-2EAB-17A3-03C0-9C571F29DB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80BCC8-57FC-4D1D-C814-7A309701B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5306D9-C951-EBDA-4AD0-C48993083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310625-DC26-D8A3-C786-C63D03E35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39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E4445C-3912-0D6C-3946-AC5405DF30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C39D5B-A5FB-18EE-41AF-15EF7300E3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5D5E66-5C3B-E57F-B7A9-1FD1BFBABC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E5ACF6-9B35-D7BF-1B0E-B02D228A3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F6D413-00D1-E191-4C2C-24ABDA808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B104A6-5A81-C878-BA27-FB7F41BE9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860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B77E0C-FAE5-827D-BBD3-3B4DF74D0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314DF-69BF-5BD7-6DE8-DC7D6D3280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5FA692-3381-6BA1-B89C-64DBFD7EE3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4129E-9AF6-4A85-BA8E-239D834A0622}" type="datetimeFigureOut">
              <a:rPr lang="en-US" smtClean="0"/>
              <a:t>8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D16C73-B777-1EE5-3DBD-97E05406B3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2E946-A06A-C309-1CE7-F43E59774B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4DFD7-476E-4923-B579-AC0D0DA2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491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CA5DD7-2E50-0468-5933-00B605330947}"/>
              </a:ext>
            </a:extLst>
          </p:cNvPr>
          <p:cNvSpPr txBox="1"/>
          <p:nvPr/>
        </p:nvSpPr>
        <p:spPr>
          <a:xfrm>
            <a:off x="5296829" y="512956"/>
            <a:ext cx="1070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2FCCD9-BFDF-A0DE-BE2C-55DB1986AEAD}"/>
              </a:ext>
            </a:extLst>
          </p:cNvPr>
          <p:cNvSpPr txBox="1"/>
          <p:nvPr/>
        </p:nvSpPr>
        <p:spPr>
          <a:xfrm>
            <a:off x="4170556" y="1182029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olled in main study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43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8AB84A-E895-150B-B8DF-F22EEE075B46}"/>
              </a:ext>
            </a:extLst>
          </p:cNvPr>
          <p:cNvSpPr txBox="1"/>
          <p:nvPr/>
        </p:nvSpPr>
        <p:spPr>
          <a:xfrm>
            <a:off x="4176134" y="3016398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olled in microbiome portion (n = 81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74F742-AD51-66CB-BB75-F2A043F8BDF5}"/>
              </a:ext>
            </a:extLst>
          </p:cNvPr>
          <p:cNvSpPr txBox="1"/>
          <p:nvPr/>
        </p:nvSpPr>
        <p:spPr>
          <a:xfrm>
            <a:off x="7660887" y="1952797"/>
            <a:ext cx="2286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lined to participate 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62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EF444C5-B67A-0FA9-5C47-C2B9711B5F8D}"/>
              </a:ext>
            </a:extLst>
          </p:cNvPr>
          <p:cNvSpPr txBox="1"/>
          <p:nvPr/>
        </p:nvSpPr>
        <p:spPr>
          <a:xfrm>
            <a:off x="7683190" y="3864339"/>
            <a:ext cx="2286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ntinued study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9)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C1A0D95-2339-701C-54F7-8CBF97757AE5}"/>
              </a:ext>
            </a:extLst>
          </p:cNvPr>
          <p:cNvCxnSpPr>
            <a:cxnSpLocks/>
            <a:endCxn id="6" idx="0"/>
          </p:cNvCxnSpPr>
          <p:nvPr/>
        </p:nvCxnSpPr>
        <p:spPr>
          <a:xfrm>
            <a:off x="5770756" y="1861812"/>
            <a:ext cx="5578" cy="115458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672EFB2-27DD-EEBE-4350-D2A6D43288A9}"/>
              </a:ext>
            </a:extLst>
          </p:cNvPr>
          <p:cNvCxnSpPr>
            <a:cxnSpLocks/>
          </p:cNvCxnSpPr>
          <p:nvPr/>
        </p:nvCxnSpPr>
        <p:spPr>
          <a:xfrm>
            <a:off x="5765180" y="2265893"/>
            <a:ext cx="189570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0AFBD02-151F-C246-A0D6-F9623740A3F5}"/>
              </a:ext>
            </a:extLst>
          </p:cNvPr>
          <p:cNvCxnSpPr>
            <a:cxnSpLocks/>
            <a:stCxn id="6" idx="2"/>
          </p:cNvCxnSpPr>
          <p:nvPr/>
        </p:nvCxnSpPr>
        <p:spPr>
          <a:xfrm flipH="1">
            <a:off x="5772614" y="3662729"/>
            <a:ext cx="3720" cy="12801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E6B537B6-6523-5A2C-59B9-BB609C96B463}"/>
              </a:ext>
            </a:extLst>
          </p:cNvPr>
          <p:cNvCxnSpPr>
            <a:cxnSpLocks/>
          </p:cNvCxnSpPr>
          <p:nvPr/>
        </p:nvCxnSpPr>
        <p:spPr>
          <a:xfrm>
            <a:off x="5783765" y="4208287"/>
            <a:ext cx="18957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C43C3C5C-EB88-8B71-5F00-A14A1350E910}"/>
              </a:ext>
            </a:extLst>
          </p:cNvPr>
          <p:cNvSpPr txBox="1"/>
          <p:nvPr/>
        </p:nvSpPr>
        <p:spPr>
          <a:xfrm>
            <a:off x="4231893" y="4936417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62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D66C07-EB82-4FD7-1D2C-0404F9F120A8}"/>
              </a:ext>
            </a:extLst>
          </p:cNvPr>
          <p:cNvSpPr txBox="1"/>
          <p:nvPr/>
        </p:nvSpPr>
        <p:spPr>
          <a:xfrm>
            <a:off x="4179172" y="5868288"/>
            <a:ext cx="5798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ORT Flow Diagram. Consort diagram of numbers of participants enrolled, discontinued and included in analysis.</a:t>
            </a:r>
          </a:p>
        </p:txBody>
      </p:sp>
    </p:spTree>
    <p:extLst>
      <p:ext uri="{BB962C8B-B14F-4D97-AF65-F5344CB8AC3E}">
        <p14:creationId xmlns:p14="http://schemas.microsoft.com/office/powerpoint/2010/main" val="27227374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CA5DD7-2E50-0468-5933-00B605330947}"/>
              </a:ext>
            </a:extLst>
          </p:cNvPr>
          <p:cNvSpPr txBox="1"/>
          <p:nvPr/>
        </p:nvSpPr>
        <p:spPr>
          <a:xfrm>
            <a:off x="5296829" y="512956"/>
            <a:ext cx="1070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2FCCD9-BFDF-A0DE-BE2C-55DB1986AEAD}"/>
              </a:ext>
            </a:extLst>
          </p:cNvPr>
          <p:cNvSpPr txBox="1"/>
          <p:nvPr/>
        </p:nvSpPr>
        <p:spPr>
          <a:xfrm>
            <a:off x="4170556" y="1182029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olled in main study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00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8AB84A-E895-150B-B8DF-F22EEE075B46}"/>
              </a:ext>
            </a:extLst>
          </p:cNvPr>
          <p:cNvSpPr txBox="1"/>
          <p:nvPr/>
        </p:nvSpPr>
        <p:spPr>
          <a:xfrm>
            <a:off x="4176134" y="3016398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olled in microbiome portion (n = 86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74F742-AD51-66CB-BB75-F2A043F8BDF5}"/>
              </a:ext>
            </a:extLst>
          </p:cNvPr>
          <p:cNvSpPr txBox="1"/>
          <p:nvPr/>
        </p:nvSpPr>
        <p:spPr>
          <a:xfrm>
            <a:off x="7660887" y="1952797"/>
            <a:ext cx="2286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lined to participate 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4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EF444C5-B67A-0FA9-5C47-C2B9711B5F8D}"/>
              </a:ext>
            </a:extLst>
          </p:cNvPr>
          <p:cNvSpPr txBox="1"/>
          <p:nvPr/>
        </p:nvSpPr>
        <p:spPr>
          <a:xfrm>
            <a:off x="7683190" y="3864339"/>
            <a:ext cx="2286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ntinued study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= 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C1A0D95-2339-701C-54F7-8CBF97757AE5}"/>
              </a:ext>
            </a:extLst>
          </p:cNvPr>
          <p:cNvCxnSpPr>
            <a:cxnSpLocks/>
            <a:endCxn id="6" idx="0"/>
          </p:cNvCxnSpPr>
          <p:nvPr/>
        </p:nvCxnSpPr>
        <p:spPr>
          <a:xfrm>
            <a:off x="5770756" y="1861812"/>
            <a:ext cx="5578" cy="115458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672EFB2-27DD-EEBE-4350-D2A6D43288A9}"/>
              </a:ext>
            </a:extLst>
          </p:cNvPr>
          <p:cNvCxnSpPr>
            <a:cxnSpLocks/>
          </p:cNvCxnSpPr>
          <p:nvPr/>
        </p:nvCxnSpPr>
        <p:spPr>
          <a:xfrm>
            <a:off x="5765180" y="2265893"/>
            <a:ext cx="189570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0AFBD02-151F-C246-A0D6-F9623740A3F5}"/>
              </a:ext>
            </a:extLst>
          </p:cNvPr>
          <p:cNvCxnSpPr>
            <a:cxnSpLocks/>
            <a:stCxn id="6" idx="2"/>
          </p:cNvCxnSpPr>
          <p:nvPr/>
        </p:nvCxnSpPr>
        <p:spPr>
          <a:xfrm flipH="1">
            <a:off x="5772614" y="3662729"/>
            <a:ext cx="3720" cy="12801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E6B537B6-6523-5A2C-59B9-BB609C96B463}"/>
              </a:ext>
            </a:extLst>
          </p:cNvPr>
          <p:cNvCxnSpPr>
            <a:cxnSpLocks/>
          </p:cNvCxnSpPr>
          <p:nvPr/>
        </p:nvCxnSpPr>
        <p:spPr>
          <a:xfrm>
            <a:off x="5783765" y="4208287"/>
            <a:ext cx="18957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C43C3C5C-EB88-8B71-5F00-A14A1350E910}"/>
              </a:ext>
            </a:extLst>
          </p:cNvPr>
          <p:cNvSpPr txBox="1"/>
          <p:nvPr/>
        </p:nvSpPr>
        <p:spPr>
          <a:xfrm>
            <a:off x="4231893" y="4936417"/>
            <a:ext cx="32004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74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A0BAB1C-817F-9DB9-0D1A-B26380291B53}"/>
              </a:ext>
            </a:extLst>
          </p:cNvPr>
          <p:cNvSpPr txBox="1"/>
          <p:nvPr/>
        </p:nvSpPr>
        <p:spPr>
          <a:xfrm>
            <a:off x="4170556" y="5883379"/>
            <a:ext cx="609426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ORT Flow Diagram. Consort diagram of numbers of participants enrolled, discontinued and included in analysis.</a:t>
            </a:r>
          </a:p>
        </p:txBody>
      </p:sp>
    </p:spTree>
    <p:extLst>
      <p:ext uri="{BB962C8B-B14F-4D97-AF65-F5344CB8AC3E}">
        <p14:creationId xmlns:p14="http://schemas.microsoft.com/office/powerpoint/2010/main" val="340126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A42D618-7168-AA61-F082-4927B70281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487" y="1675865"/>
            <a:ext cx="8443414" cy="40781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B01DFFD-6354-B8BC-95B4-E9AD4A00CFFF}"/>
              </a:ext>
            </a:extLst>
          </p:cNvPr>
          <p:cNvSpPr txBox="1"/>
          <p:nvPr/>
        </p:nvSpPr>
        <p:spPr>
          <a:xfrm>
            <a:off x="2358390" y="727501"/>
            <a:ext cx="74752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cked Bar-Plot of Microbiota Composition: Study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14BD37-3CC3-37F2-7ED8-4593A996EA58}"/>
              </a:ext>
            </a:extLst>
          </p:cNvPr>
          <p:cNvSpPr txBox="1"/>
          <p:nvPr/>
        </p:nvSpPr>
        <p:spPr>
          <a:xfrm>
            <a:off x="1564487" y="5871411"/>
            <a:ext cx="84434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relative abundance of microbial families across all samples. Samples are grouped by individual with a total of 62 samples depicted. The top 10 most abundant bacterial families present in Study 1 are identical to those in Study 2 with the exception of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rrucomicrobiaceae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  </a:t>
            </a:r>
            <a:endParaRPr lang="en-US" sz="14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43495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42B933-157A-5106-BEC4-CB0B9AF59A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377" y="1550206"/>
            <a:ext cx="9297246" cy="420257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263ACD-8983-5C89-31B4-2CD9836CF17E}"/>
              </a:ext>
            </a:extLst>
          </p:cNvPr>
          <p:cNvSpPr txBox="1"/>
          <p:nvPr/>
        </p:nvSpPr>
        <p:spPr>
          <a:xfrm>
            <a:off x="2042615" y="301149"/>
            <a:ext cx="8106770" cy="1022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4</a:t>
            </a: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acked Bar-Plot of Microbiota Composition: Study 2</a:t>
            </a: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9C06175-8C3B-06B3-2B4C-52288E53C3E1}"/>
              </a:ext>
            </a:extLst>
          </p:cNvPr>
          <p:cNvSpPr txBox="1"/>
          <p:nvPr/>
        </p:nvSpPr>
        <p:spPr>
          <a:xfrm>
            <a:off x="1564487" y="5871411"/>
            <a:ext cx="8443414" cy="815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relative abundance of microbial families across all samples. Samples are grouped by individual with a total of 74 samples depicted. The top 10 most abundant bacterial families present in Study 2 are identical to those in Study 1 with the exception of </a:t>
            </a:r>
            <a:r>
              <a:rPr lang="en-US" sz="14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kenellaceae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980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26</TotalTime>
  <Words>254</Words>
  <Application>Microsoft Office PowerPoint</Application>
  <PresentationFormat>Widescreen</PresentationFormat>
  <Paragraphs>35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CLA Health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se, Desiree</dc:creator>
  <cp:lastModifiedBy>Chase, Desiree</cp:lastModifiedBy>
  <cp:revision>6</cp:revision>
  <dcterms:created xsi:type="dcterms:W3CDTF">2024-04-18T17:23:05Z</dcterms:created>
  <dcterms:modified xsi:type="dcterms:W3CDTF">2024-08-30T03:12:37Z</dcterms:modified>
</cp:coreProperties>
</file>